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  <a:srgbClr val="FFFD7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038"/>
    <p:restoredTop sz="94752"/>
  </p:normalViewPr>
  <p:slideViewPr>
    <p:cSldViewPr snapToGrid="0" showGuides="1">
      <p:cViewPr varScale="1">
        <p:scale>
          <a:sx n="108" d="100"/>
          <a:sy n="108" d="100"/>
        </p:scale>
        <p:origin x="224" y="3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H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1F06D9-AA6F-C143-BB2A-81EC095295BB}" type="datetimeFigureOut">
              <a:rPr lang="en-HU" smtClean="0"/>
              <a:t>7/14/25</a:t>
            </a:fld>
            <a:endParaRPr lang="en-H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H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55971E-3C54-AE4C-9258-D1B9432DA1DD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932325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HU" dirty="0"/>
              <a:t>Multimedia Supplement 1: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iginal and updated Philips patient monitor alarm sounds investigated in this study. To play each sound, hover over a given icon and press play. </a:t>
            </a:r>
            <a:endParaRPr lang="en-HU" sz="1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55971E-3C54-AE4C-9258-D1B9432DA1DD}" type="slidenum">
              <a:rPr lang="en-HU" smtClean="0"/>
              <a:t>2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31394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8ADA8-51AC-DAFA-7817-F876D09040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5E7A51-548D-D0F9-1C37-4EAE79B448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AFE0DD-0188-522B-B605-A1DF739C3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B8D0E-A2A2-7D62-E645-877078CD6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5D043-171A-9BAC-D31B-6625EE441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294524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C01E8-353F-F0C5-252D-ED2C7876E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15B58F-A92D-9AEE-3ECA-56DB36552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4E8F6C-0C77-A896-C638-EAEB867BA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85FC7-A942-70BB-9DCE-F38836595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66ADC-834F-55BE-08AD-5383269B5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93517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E58705-67FE-A20B-A79E-8502FCCF5F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4A89A6-65DC-D9F1-81A2-10CB0325A2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E45AE-2C53-8384-87F4-4385C2E59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1B110-FDE7-80C0-39E6-B1F695825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C594C-5CF2-2591-4F34-39A245F81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801422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FEE4A3-B101-4E95-06DE-1E403C88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FC20B7-40EB-91CC-AAB4-776882403C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819AF0-A288-5E68-392D-5B44CE6C6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E0119-EA57-06D0-6479-F4B76D093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1D9E4-265A-4E2A-3162-193FDD2A7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49706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F4C43-2BC2-EEC8-3414-BA5593CC9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3EEDAA-A76C-B8C7-0535-C6FECBD40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2F73BE-20BC-8C50-71CA-1AAE8090D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5C0A5-63F1-5FE6-0A70-A3CBC8C85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A4CBDF-A6F4-5763-BC64-494E919F2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46179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BC64F-FE14-7B79-08AD-6DB4EB11F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C6EF98-EACA-FC6A-4D33-5B47B78AF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4CF842-0C1B-2784-7E59-79E89ED48A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B06BE3-7395-B85C-5153-4C5A94CFF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5898F-F06D-E5F8-AF19-2D7E30C67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A29B6F-D7D8-2BC2-3F8A-9250CB0D7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733778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6BC4D4-BD93-B5AC-A667-089806A36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922251-D8BF-8D5A-BEA3-E319EB46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EE18A1-FC37-632D-5294-96C47CA42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452F5-BE96-FA0E-AE3E-2159D4E05A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C9ABA0-50F3-5F87-2D1E-4FEDBF0B98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3C3AD9-CF43-7A5B-ACE2-3710373A3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A8CAA4-A5FD-74EE-CB0E-7CD81537C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65A786-F60F-F76F-BF08-25693CFF0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950228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3840E-3DFE-F4C8-AD2C-87FC0B537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02DAF1-84F0-A31E-71B8-E6094E235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914694-9277-CD30-AB87-CD8634750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22FCAC-1ED9-8984-6740-D61980840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323763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65E17B-471B-0FDD-7A84-DEF2D93EF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55CD4F-C45A-EFE2-028B-B5A28093D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72D907-E06A-593E-2F72-C48775485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303289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3C38A-BBC2-A548-71F9-DDEBD37A1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E30D52-8B5A-8329-D7F4-FA7A5A7F93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EC8F1-C6BD-6833-4CC7-CE732AC9A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CE2D02-0052-F11E-3CF5-1851F3C1F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AEB5C2-4A94-432E-89D4-4358489F9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08494D-4C10-777F-62C3-75270AEA3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860105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0D002-0858-C8EE-3556-89949A5C3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EBE66A-6DDF-7CE9-8B2E-6033E52ECD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H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AA169D-9E12-48FA-286F-450179AEF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105AF0-C654-43C4-ABA6-D49920A93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512736-C8D4-A467-79E3-4549C0C4C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A4E5A9-F85E-D812-84C6-200AB8C7F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3030666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F8FC5B-99FA-3CAC-5E61-DEC317EE6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1E7B6C-9AE3-D163-F39B-6E1B4928DB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36A8C4-7C4D-3B29-02C5-D95034B526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0569B4-31DC-86CA-F10E-CF536CB1C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A26FD-5B0E-8683-9D2D-8D8BBC4B23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696317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audio" Target="../media/media4.wav"/><Relationship Id="rId13" Type="http://schemas.openxmlformats.org/officeDocument/2006/relationships/slideLayout" Target="../slideLayouts/slideLayout2.xml"/><Relationship Id="rId3" Type="http://schemas.microsoft.com/office/2007/relationships/media" Target="../media/media2.wav"/><Relationship Id="rId7" Type="http://schemas.microsoft.com/office/2007/relationships/media" Target="../media/media4.wav"/><Relationship Id="rId12" Type="http://schemas.openxmlformats.org/officeDocument/2006/relationships/audio" Target="../media/media6.wav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audio" Target="../media/media3.wav"/><Relationship Id="rId11" Type="http://schemas.microsoft.com/office/2007/relationships/media" Target="../media/media6.wav"/><Relationship Id="rId5" Type="http://schemas.microsoft.com/office/2007/relationships/media" Target="../media/media3.wav"/><Relationship Id="rId15" Type="http://schemas.openxmlformats.org/officeDocument/2006/relationships/image" Target="../media/image1.png"/><Relationship Id="rId10" Type="http://schemas.openxmlformats.org/officeDocument/2006/relationships/audio" Target="../media/media5.wav"/><Relationship Id="rId4" Type="http://schemas.openxmlformats.org/officeDocument/2006/relationships/audio" Target="../media/media2.wav"/><Relationship Id="rId9" Type="http://schemas.microsoft.com/office/2007/relationships/media" Target="../media/media5.wav"/><Relationship Id="rId1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>
            <a:lumMod val="25000"/>
            <a:lumOff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EEF26-84E4-714A-FDB2-9785F8EC58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041400"/>
            <a:ext cx="9144000" cy="2387600"/>
          </a:xfrm>
        </p:spPr>
        <p:txBody>
          <a:bodyPr>
            <a:norm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3200" dirty="0">
                <a:effectLst/>
                <a:latin typeface="Helvetica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Multimedia </a:t>
            </a:r>
            <a:r>
              <a:rPr lang="en-GB" sz="3200" dirty="0">
                <a:latin typeface="Helvetica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Appendix 1</a:t>
            </a:r>
            <a:r>
              <a:rPr lang="en-US" sz="3200" dirty="0">
                <a:effectLst/>
                <a:latin typeface="Helvetica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HU" sz="88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4F8B54F2-D985-4B50-CE8A-4B9DB344B683}"/>
              </a:ext>
            </a:extLst>
          </p:cNvPr>
          <p:cNvSpPr txBox="1"/>
          <p:nvPr/>
        </p:nvSpPr>
        <p:spPr>
          <a:xfrm>
            <a:off x="2937510" y="3897630"/>
            <a:ext cx="65271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noProof="0" dirty="0"/>
              <a:t>Alarm Sounds available under:</a:t>
            </a:r>
          </a:p>
          <a:p>
            <a:r>
              <a:rPr lang="en-GB" noProof="0" dirty="0"/>
              <a:t>https://</a:t>
            </a:r>
            <a:r>
              <a:rPr lang="en-GB" noProof="0" dirty="0" err="1"/>
              <a:t>www.philips.co.uk</a:t>
            </a:r>
            <a:r>
              <a:rPr lang="en-GB" noProof="0" dirty="0"/>
              <a:t>/healthcare/technology/alarm-sounds</a:t>
            </a:r>
          </a:p>
        </p:txBody>
      </p:sp>
    </p:spTree>
    <p:extLst>
      <p:ext uri="{BB962C8B-B14F-4D97-AF65-F5344CB8AC3E}">
        <p14:creationId xmlns:p14="http://schemas.microsoft.com/office/powerpoint/2010/main" val="2394209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F0833D20-5EFF-35E9-07E3-AF950D9B5E15}"/>
              </a:ext>
            </a:extLst>
          </p:cNvPr>
          <p:cNvSpPr/>
          <p:nvPr/>
        </p:nvSpPr>
        <p:spPr>
          <a:xfrm>
            <a:off x="0" y="3429000"/>
            <a:ext cx="12192000" cy="3429000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U"/>
          </a:p>
        </p:txBody>
      </p:sp>
      <p:pic>
        <p:nvPicPr>
          <p:cNvPr id="5" name="USZ-Traditional-Yellow-Bedside-wAmbience">
            <a:hlinkClick r:id="" action="ppaction://media"/>
            <a:extLst>
              <a:ext uri="{FF2B5EF4-FFF2-40B4-BE49-F238E27FC236}">
                <a16:creationId xmlns:a16="http://schemas.microsoft.com/office/drawing/2014/main" id="{E7DE63CD-BC13-C75A-A5DA-FC1464D5BB54}"/>
              </a:ext>
            </a:extLst>
          </p:cNvPr>
          <p:cNvPicPr>
            <a:picLocks noGrp="1" noChangeAspect="1"/>
          </p:cNvPicPr>
          <p:nvPr>
            <p:ph idx="1"/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5399315" y="1357086"/>
            <a:ext cx="1393371" cy="1393371"/>
          </a:xfrm>
          <a:prstGeom prst="ellipse">
            <a:avLst/>
          </a:prstGeom>
          <a:solidFill>
            <a:srgbClr val="FFFD78">
              <a:alpha val="59216"/>
            </a:srgbClr>
          </a:solidFill>
        </p:spPr>
      </p:pic>
      <p:pic>
        <p:nvPicPr>
          <p:cNvPr id="6" name="USZ-Traditional-Cyan-Bedside-wAmbience">
            <a:hlinkClick r:id="" action="ppaction://media"/>
            <a:extLst>
              <a:ext uri="{FF2B5EF4-FFF2-40B4-BE49-F238E27FC236}">
                <a16:creationId xmlns:a16="http://schemas.microsoft.com/office/drawing/2014/main" id="{2BD40FB9-0675-5D69-CC66-A0B90A012D3C}"/>
              </a:ext>
            </a:extLst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2002972" y="1357086"/>
            <a:ext cx="1393371" cy="1393371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</p:spPr>
      </p:pic>
      <p:pic>
        <p:nvPicPr>
          <p:cNvPr id="7" name="USZ-Traditional-Red-Bedside-wAmbience">
            <a:hlinkClick r:id="" action="ppaction://media"/>
            <a:extLst>
              <a:ext uri="{FF2B5EF4-FFF2-40B4-BE49-F238E27FC236}">
                <a16:creationId xmlns:a16="http://schemas.microsoft.com/office/drawing/2014/main" id="{16712705-111C-4278-4ED7-87283A3AABDD}"/>
              </a:ext>
            </a:extLst>
          </p:cNvPr>
          <p:cNvPicPr>
            <a:picLocks noChangeAspect="1"/>
          </p:cNvPicPr>
          <p:nvPr>
            <a:audi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8795658" y="4107543"/>
            <a:ext cx="1393371" cy="1393371"/>
          </a:xfrm>
          <a:prstGeom prst="ellipse">
            <a:avLst/>
          </a:prstGeom>
          <a:solidFill>
            <a:srgbClr val="FF2600"/>
          </a:solidFill>
        </p:spPr>
      </p:pic>
      <p:pic>
        <p:nvPicPr>
          <p:cNvPr id="8" name="USZ-P2021-Cyan-Bedside-wAmbience">
            <a:hlinkClick r:id="" action="ppaction://media"/>
            <a:extLst>
              <a:ext uri="{FF2B5EF4-FFF2-40B4-BE49-F238E27FC236}">
                <a16:creationId xmlns:a16="http://schemas.microsoft.com/office/drawing/2014/main" id="{ACB4874D-B593-FB79-1C12-51CBC6EAE8C8}"/>
              </a:ext>
            </a:extLst>
          </p:cNvPr>
          <p:cNvPicPr>
            <a:picLocks noChangeAspect="1"/>
          </p:cNvPicPr>
          <p:nvPr>
            <a:audi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2002972" y="4107543"/>
            <a:ext cx="1393371" cy="1393371"/>
          </a:xfrm>
          <a:prstGeom prst="ellipse">
            <a:avLst/>
          </a:prstGeom>
          <a:solidFill>
            <a:schemeClr val="tx2">
              <a:lumMod val="50000"/>
              <a:lumOff val="50000"/>
            </a:schemeClr>
          </a:solidFill>
        </p:spPr>
      </p:pic>
      <p:pic>
        <p:nvPicPr>
          <p:cNvPr id="9" name="USZ-P2021-Red-Bedside-wAmbience">
            <a:hlinkClick r:id="" action="ppaction://media"/>
            <a:extLst>
              <a:ext uri="{FF2B5EF4-FFF2-40B4-BE49-F238E27FC236}">
                <a16:creationId xmlns:a16="http://schemas.microsoft.com/office/drawing/2014/main" id="{74F98B84-2E9F-4A4D-A934-B51669360598}"/>
              </a:ext>
            </a:extLst>
          </p:cNvPr>
          <p:cNvPicPr>
            <a:picLocks noChangeAspect="1"/>
          </p:cNvPicPr>
          <p:nvPr>
            <a:audi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8795658" y="1357086"/>
            <a:ext cx="1393371" cy="1393371"/>
          </a:xfrm>
          <a:prstGeom prst="ellipse">
            <a:avLst/>
          </a:prstGeom>
          <a:solidFill>
            <a:srgbClr val="FF2600">
              <a:alpha val="52549"/>
            </a:srgbClr>
          </a:solidFill>
        </p:spPr>
      </p:pic>
      <p:pic>
        <p:nvPicPr>
          <p:cNvPr id="10" name="USZ-P2021-Yellow-Bedside-wAmbience">
            <a:hlinkClick r:id="" action="ppaction://media"/>
            <a:extLst>
              <a:ext uri="{FF2B5EF4-FFF2-40B4-BE49-F238E27FC236}">
                <a16:creationId xmlns:a16="http://schemas.microsoft.com/office/drawing/2014/main" id="{145ACFBD-ADAA-66B2-44A3-06E3D7B4AD7E}"/>
              </a:ext>
            </a:extLst>
          </p:cNvPr>
          <p:cNvPicPr>
            <a:picLocks noChangeAspect="1"/>
          </p:cNvPicPr>
          <p:nvPr>
            <a:audi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5399315" y="4107543"/>
            <a:ext cx="1393371" cy="1393371"/>
          </a:xfrm>
          <a:prstGeom prst="ellipse">
            <a:avLst/>
          </a:prstGeom>
          <a:solidFill>
            <a:srgbClr val="FFFF00"/>
          </a:solidFill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629D822-265F-62B3-BAD0-EBD2C3D2B9AF}"/>
              </a:ext>
            </a:extLst>
          </p:cNvPr>
          <p:cNvSpPr txBox="1"/>
          <p:nvPr/>
        </p:nvSpPr>
        <p:spPr>
          <a:xfrm>
            <a:off x="1950664" y="6100763"/>
            <a:ext cx="1369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Low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A3A908-2F64-6C6F-880E-4914C81AB15D}"/>
              </a:ext>
            </a:extLst>
          </p:cNvPr>
          <p:cNvSpPr txBox="1"/>
          <p:nvPr/>
        </p:nvSpPr>
        <p:spPr>
          <a:xfrm>
            <a:off x="5181807" y="6100763"/>
            <a:ext cx="1790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Medium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A517DD5-29B5-8B89-72E5-344D8AD7C522}"/>
              </a:ext>
            </a:extLst>
          </p:cNvPr>
          <p:cNvSpPr txBox="1"/>
          <p:nvPr/>
        </p:nvSpPr>
        <p:spPr>
          <a:xfrm>
            <a:off x="8891286" y="6100763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High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795D39A-6A11-B930-F5E0-3CA418BCE56A}"/>
              </a:ext>
            </a:extLst>
          </p:cNvPr>
          <p:cNvSpPr txBox="1"/>
          <p:nvPr/>
        </p:nvSpPr>
        <p:spPr>
          <a:xfrm>
            <a:off x="195942" y="1707724"/>
            <a:ext cx="13933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itchFamily="2" charset="0"/>
              </a:rPr>
              <a:t>Original alarm sounds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CEE2AAD-7C3B-26C1-163E-1BA05789C0C9}"/>
              </a:ext>
            </a:extLst>
          </p:cNvPr>
          <p:cNvSpPr txBox="1"/>
          <p:nvPr/>
        </p:nvSpPr>
        <p:spPr>
          <a:xfrm>
            <a:off x="195942" y="4342563"/>
            <a:ext cx="13933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itchFamily="2" charset="0"/>
              </a:rPr>
              <a:t>Updated alarm sounds</a:t>
            </a:r>
            <a:endParaRPr lang="en-HU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2883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95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80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21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8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6" dur="19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2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  <p:audio>
              <p:cMediaNode vol="80000">
                <p:cTn id="28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  <p:audio>
              <p:cMediaNode vol="80000">
                <p:cTn id="29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  <p:audio>
              <p:cMediaNode vol="80000">
                <p:cTn id="30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  <p:audio>
              <p:cMediaNode vol="80000">
                <p:cTn id="3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  <p:audio>
              <p:cMediaNode vol="80000">
                <p:cTn id="3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Macintosh PowerPoint</Application>
  <PresentationFormat>Breitbild</PresentationFormat>
  <Paragraphs>10</Paragraphs>
  <Slides>2</Slides>
  <Notes>1</Notes>
  <HiddenSlides>0</HiddenSlides>
  <MMClips>6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Helvetica</vt:lpstr>
      <vt:lpstr>Times New Roman</vt:lpstr>
      <vt:lpstr>Office Theme</vt:lpstr>
      <vt:lpstr>Multimedia Appendix 1 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nn Cynthia Alexandra</dc:creator>
  <cp:lastModifiedBy>Roche Tadzio Raoul</cp:lastModifiedBy>
  <cp:revision>16</cp:revision>
  <dcterms:created xsi:type="dcterms:W3CDTF">2024-12-28T12:31:26Z</dcterms:created>
  <dcterms:modified xsi:type="dcterms:W3CDTF">2025-07-14T12:47:11Z</dcterms:modified>
</cp:coreProperties>
</file>